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F14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65" autoAdjust="0"/>
    <p:restoredTop sz="94608" autoAdjust="0"/>
  </p:normalViewPr>
  <p:slideViewPr>
    <p:cSldViewPr>
      <p:cViewPr>
        <p:scale>
          <a:sx n="70" d="100"/>
          <a:sy n="70" d="100"/>
        </p:scale>
        <p:origin x="-1212" y="-8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634FF9-C2AB-4E97-9A7E-19E00212F2FA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FA26E0-B82A-49EE-AE77-9A2C181AB28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641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BFA26E0-B82A-49EE-AE77-9A2C181AB287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2" descr="http://mordred.bioc.cam.ac.uk/~rapper/tmp/1365174028/1365174028-0.jpg"/>
          <p:cNvPicPr>
            <a:picLocks noChangeAspect="1" noChangeArrowheads="1"/>
          </p:cNvPicPr>
          <p:nvPr/>
        </p:nvPicPr>
        <p:blipFill>
          <a:blip r:embed="rId3" cstate="print"/>
          <a:srcRect l="52208" t="86042" r="9361" b="6979"/>
          <a:stretch>
            <a:fillRect/>
          </a:stretch>
        </p:blipFill>
        <p:spPr bwMode="auto">
          <a:xfrm>
            <a:off x="3276600" y="5475237"/>
            <a:ext cx="2623884" cy="544563"/>
          </a:xfrm>
          <a:prstGeom prst="rect">
            <a:avLst/>
          </a:prstGeom>
          <a:noFill/>
        </p:spPr>
      </p:pic>
      <p:pic>
        <p:nvPicPr>
          <p:cNvPr id="10" name="Picture 2" descr="http://mordred.bioc.cam.ac.uk/~rapper/tmp/1365174028/1365174028-0.jpg"/>
          <p:cNvPicPr>
            <a:picLocks noChangeAspect="1" noChangeArrowheads="1"/>
          </p:cNvPicPr>
          <p:nvPr/>
        </p:nvPicPr>
        <p:blipFill>
          <a:blip r:embed="rId3" cstate="print"/>
          <a:srcRect l="12327" t="86042" r="48517" b="6979"/>
          <a:stretch>
            <a:fillRect/>
          </a:stretch>
        </p:blipFill>
        <p:spPr bwMode="auto">
          <a:xfrm>
            <a:off x="3276600" y="4941837"/>
            <a:ext cx="2673384" cy="544563"/>
          </a:xfrm>
          <a:prstGeom prst="rect">
            <a:avLst/>
          </a:prstGeom>
          <a:noFill/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6200" y="3559120"/>
            <a:ext cx="3276600" cy="30849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5" cstate="print"/>
          <a:srcRect r="7859" b="3555"/>
          <a:stretch>
            <a:fillRect/>
          </a:stretch>
        </p:blipFill>
        <p:spPr bwMode="auto">
          <a:xfrm>
            <a:off x="5943600" y="457200"/>
            <a:ext cx="3124200" cy="310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0" y="538993"/>
            <a:ext cx="3352800" cy="32710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0" name="TextBox 29"/>
          <p:cNvSpPr txBox="1"/>
          <p:nvPr/>
        </p:nvSpPr>
        <p:spPr>
          <a:xfrm>
            <a:off x="5105400" y="762000"/>
            <a:ext cx="1295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PDB ID:1EX4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124200" y="685800"/>
            <a:ext cx="1371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PDB ID:3OY9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124200" y="3581400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Model 6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943600" y="3429000"/>
            <a:ext cx="3200400" cy="32924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TextBox 10"/>
          <p:cNvSpPr txBox="1"/>
          <p:nvPr/>
        </p:nvSpPr>
        <p:spPr>
          <a:xfrm>
            <a:off x="5562600" y="3657600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Model 7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0" y="0"/>
            <a:ext cx="66752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smtClean="0"/>
              <a:t>S7: Ramachandran plot analysis of models 6 and 7 compared to the two lead templates</a:t>
            </a:r>
            <a:endParaRPr lang="en-US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Custom 1">
      <a:majorFont>
        <a:latin typeface="Arial Narrow"/>
        <a:ea typeface=""/>
        <a:cs typeface=""/>
      </a:majorFont>
      <a:minorFont>
        <a:latin typeface="Arial Narrow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31</TotalTime>
  <Words>25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llustriousII</dc:creator>
  <cp:lastModifiedBy>Estrella Moyal2</cp:lastModifiedBy>
  <cp:revision>408</cp:revision>
  <dcterms:created xsi:type="dcterms:W3CDTF">2015-02-06T16:45:11Z</dcterms:created>
  <dcterms:modified xsi:type="dcterms:W3CDTF">2015-04-23T14:34:10Z</dcterms:modified>
</cp:coreProperties>
</file>